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0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18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218740880"/>
              </p:ext>
            </p:extLst>
          </p:nvPr>
        </p:nvGraphicFramePr>
        <p:xfrm>
          <a:off x="1714500" y="3985863"/>
          <a:ext cx="3429000" cy="2329561"/>
        </p:xfrm>
        <a:graphic>
          <a:graphicData uri="http://schemas.openxmlformats.org/drawingml/2006/table">
            <a:tbl>
              <a:tblPr/>
              <a:tblGrid>
                <a:gridCol w="1714500"/>
                <a:gridCol w="1714500"/>
              </a:tblGrid>
              <a:tr h="200025">
                <a:tc gridSpan="2">
                  <a:txBody>
                    <a:bodyPr/>
                    <a:lstStyle/>
                    <a:p>
                      <a:pPr fontAlgn="b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b="1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Table </a:t>
                      </a:r>
                      <a:r>
                        <a:rPr lang="en-AU" sz="1200" b="1" kern="120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2. </a:t>
                      </a:r>
                      <a:r>
                        <a:rPr lang="en-AU" sz="1200" kern="1200" dirty="0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Chemical composition of </a:t>
                      </a:r>
                      <a:r>
                        <a:rPr lang="en-AU" sz="1200" kern="1200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ea typeface="Times New Roman"/>
                          <a:cs typeface="Times New Roman"/>
                        </a:rPr>
                        <a:t>SeSW</a:t>
                      </a:r>
                      <a:endParaRPr lang="en-AU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AU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AU" sz="1100"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</a:pPr>
                      <a:endParaRPr lang="en-AU" sz="1100">
                        <a:effectLst/>
                        <a:latin typeface="Calibri"/>
                        <a:cs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b="1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Ingredients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b="1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Concentration per </a:t>
                      </a:r>
                      <a:r>
                        <a:rPr lang="en-AU" sz="1200" b="1" kern="1200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L*</a:t>
                      </a:r>
                      <a:endParaRPr lang="en-AU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KH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PO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585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K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HPO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218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Na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HPO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. 7H2O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503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NaNO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3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015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NH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Cl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055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CaCl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0275 g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MgSO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4</a:t>
                      </a: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.7H2O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0.0225 g 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Se0</a:t>
                      </a:r>
                      <a:r>
                        <a:rPr lang="en-AU" sz="1200" kern="1200" baseline="-2500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2</a:t>
                      </a:r>
                      <a:endParaRPr lang="en-AU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ts val="1575"/>
                        </a:lnSpc>
                        <a:spcAft>
                          <a:spcPts val="0"/>
                        </a:spcAft>
                      </a:pPr>
                      <a:r>
                        <a:rPr lang="en-AU" sz="1200" kern="1200" dirty="0">
                          <a:solidFill>
                            <a:srgbClr val="000000"/>
                          </a:solidFill>
                          <a:effectLst/>
                          <a:latin typeface="Calibri"/>
                          <a:ea typeface="Times New Roman"/>
                          <a:cs typeface="Calibri"/>
                        </a:rPr>
                        <a:t>800 µg</a:t>
                      </a:r>
                      <a:endParaRPr lang="en-AU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683877" y="6505472"/>
            <a:ext cx="1376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* per L of seawater</a:t>
            </a:r>
            <a:endParaRPr lang="en-AU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2132856" y="8216375"/>
            <a:ext cx="2605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dditional file </a:t>
            </a:r>
            <a:r>
              <a:rPr lang="en-AU" b="1" dirty="0" smtClean="0"/>
              <a:t>9: Table S2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xmlns="" val="12511729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2</TotalTime>
  <Words>49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31:38Z</dcterms:modified>
</cp:coreProperties>
</file>